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docx" ContentType="application/vnd.openxmlformats-officedocument.wordprocessingml.documen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A58E22-F69E-4C96-ACC5-19028A51159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E99190-5EF2-4765-983B-6DA20776DC0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2F04F9-BD71-49E8-B0DE-963E8A2D5E5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12594F-36C4-45B9-95D7-B35EDBF9CB7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C74195-C1F3-4545-8782-BD753B4413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D14667-3843-4A87-9B3A-A04D9943782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5400CA-ED83-4D48-BDE9-09F72EB873B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DA0536-FBF0-432D-895D-89200C9F1F4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E34ECF-934F-4166-B31B-249A945F2AF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A63CC6-9063-4134-A818-021FF66F23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AC33D4-4719-4273-B08E-F97121FC8F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AAB8D2-3E87-4264-B954-7395CE8E3ED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BB0F0BD-B880-4B20-AE7C-540F6BAD7EAB}" type="slidenum">
              <a:rPr b="0" lang="it-I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docx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787320" y="290520"/>
          <a:ext cx="5226120" cy="7331040"/>
        </p:xfrm>
        <a:graphic>
          <a:graphicData uri="http://schemas.openxmlformats.org/presentationml/2006/ole">
            <p:oleObj progId="Word.Document.12"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787320" y="290520"/>
                    <a:ext cx="5226120" cy="7331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"/>
          <p:cNvSpPr/>
          <p:nvPr/>
        </p:nvSpPr>
        <p:spPr>
          <a:xfrm>
            <a:off x="419040" y="7769160"/>
            <a:ext cx="596268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Amino acid sequence alignment of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Six3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 genes from different vertebrate species. Partially or completely conserved amino acids are indicated in blue or red, respectively. Non conserved sequences are in black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HSIX3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, human;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mSix3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, mouse;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rSix3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, rat;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cSix3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, chicken,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olSix3.1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 and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olSix3.2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, medaka;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zSix3a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 and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zSix3b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, zebrafish and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Xsix3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,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Xenopus laevis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Six3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gene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58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4-02T19:25:00Z</dcterms:created>
  <dc:creator>Ivan Conte</dc:creator>
  <dc:description/>
  <dc:language>en-US</dc:language>
  <cp:lastModifiedBy>Paola</cp:lastModifiedBy>
  <dcterms:modified xsi:type="dcterms:W3CDTF">2007-06-29T16:27:51Z</dcterms:modified>
  <cp:revision>89</cp:revision>
  <dc:subject/>
  <dc:title>Diapositiva 1</dc:title>
</cp:coreProperties>
</file>